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10" autoAdjust="0"/>
    <p:restoredTop sz="88813" autoAdjust="0"/>
  </p:normalViewPr>
  <p:slideViewPr>
    <p:cSldViewPr snapToGrid="0" showGuides="1">
      <p:cViewPr varScale="1">
        <p:scale>
          <a:sx n="151" d="100"/>
          <a:sy n="151" d="100"/>
        </p:scale>
        <p:origin x="150" y="31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Real-time PCR-positive without mutation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bg1"/>
                    </a:solidFill>
                    <a:latin typeface="Century" panose="02040604050505020304" pitchFamily="18" charset="0"/>
                    <a:ea typeface="+mn-ea"/>
                    <a:cs typeface="+mn-cs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13</c:f>
              <c:strCache>
                <c:ptCount val="12"/>
                <c:pt idx="0">
                  <c:v>0-24</c:v>
                </c:pt>
                <c:pt idx="1">
                  <c:v>25-48</c:v>
                </c:pt>
                <c:pt idx="2">
                  <c:v>49-72</c:v>
                </c:pt>
                <c:pt idx="3">
                  <c:v>73-96</c:v>
                </c:pt>
                <c:pt idx="4">
                  <c:v>97-120</c:v>
                </c:pt>
                <c:pt idx="5">
                  <c:v>121-144</c:v>
                </c:pt>
                <c:pt idx="6">
                  <c:v>145-168</c:v>
                </c:pt>
                <c:pt idx="7">
                  <c:v>169-192</c:v>
                </c:pt>
                <c:pt idx="8">
                  <c:v>193-216</c:v>
                </c:pt>
                <c:pt idx="9">
                  <c:v>217-240</c:v>
                </c:pt>
                <c:pt idx="10">
                  <c:v>240-</c:v>
                </c:pt>
                <c:pt idx="11">
                  <c:v>no fever</c:v>
                </c:pt>
              </c:strCache>
            </c:strRef>
          </c:cat>
          <c:val>
            <c:numRef>
              <c:f>Sheet1!$B$2:$B$13</c:f>
              <c:numCache>
                <c:formatCode>General</c:formatCode>
                <c:ptCount val="12"/>
                <c:pt idx="0">
                  <c:v>5</c:v>
                </c:pt>
                <c:pt idx="1">
                  <c:v>6</c:v>
                </c:pt>
                <c:pt idx="2">
                  <c:v>8</c:v>
                </c:pt>
                <c:pt idx="3">
                  <c:v>15</c:v>
                </c:pt>
                <c:pt idx="4">
                  <c:v>7</c:v>
                </c:pt>
                <c:pt idx="5">
                  <c:v>12</c:v>
                </c:pt>
                <c:pt idx="6">
                  <c:v>5</c:v>
                </c:pt>
                <c:pt idx="7">
                  <c:v>2</c:v>
                </c:pt>
                <c:pt idx="8">
                  <c:v>1</c:v>
                </c:pt>
                <c:pt idx="9">
                  <c:v>1</c:v>
                </c:pt>
                <c:pt idx="10">
                  <c:v>3</c:v>
                </c:pt>
                <c:pt idx="11">
                  <c:v>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E84-47A2-AB42-5E66CD168D16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Real-time PCR-positive with mutation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/>
                    </a:solidFill>
                    <a:latin typeface="Century" panose="02040604050505020304" pitchFamily="18" charset="0"/>
                    <a:ea typeface="+mn-ea"/>
                    <a:cs typeface="+mn-cs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13</c:f>
              <c:strCache>
                <c:ptCount val="12"/>
                <c:pt idx="0">
                  <c:v>0-24</c:v>
                </c:pt>
                <c:pt idx="1">
                  <c:v>25-48</c:v>
                </c:pt>
                <c:pt idx="2">
                  <c:v>49-72</c:v>
                </c:pt>
                <c:pt idx="3">
                  <c:v>73-96</c:v>
                </c:pt>
                <c:pt idx="4">
                  <c:v>97-120</c:v>
                </c:pt>
                <c:pt idx="5">
                  <c:v>121-144</c:v>
                </c:pt>
                <c:pt idx="6">
                  <c:v>145-168</c:v>
                </c:pt>
                <c:pt idx="7">
                  <c:v>169-192</c:v>
                </c:pt>
                <c:pt idx="8">
                  <c:v>193-216</c:v>
                </c:pt>
                <c:pt idx="9">
                  <c:v>217-240</c:v>
                </c:pt>
                <c:pt idx="10">
                  <c:v>240-</c:v>
                </c:pt>
                <c:pt idx="11">
                  <c:v>no fever</c:v>
                </c:pt>
              </c:strCache>
            </c:strRef>
          </c:cat>
          <c:val>
            <c:numRef>
              <c:f>Sheet1!$C$2:$C$13</c:f>
              <c:numCache>
                <c:formatCode>General</c:formatCode>
                <c:ptCount val="12"/>
                <c:pt idx="4">
                  <c:v>3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1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E84-47A2-AB42-5E66CD168D16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Real-time PCR-negative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/>
                    </a:solidFill>
                    <a:latin typeface="Century" panose="02040604050505020304" pitchFamily="18" charset="0"/>
                    <a:ea typeface="+mn-ea"/>
                    <a:cs typeface="+mn-cs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13</c:f>
              <c:strCache>
                <c:ptCount val="12"/>
                <c:pt idx="0">
                  <c:v>0-24</c:v>
                </c:pt>
                <c:pt idx="1">
                  <c:v>25-48</c:v>
                </c:pt>
                <c:pt idx="2">
                  <c:v>49-72</c:v>
                </c:pt>
                <c:pt idx="3">
                  <c:v>73-96</c:v>
                </c:pt>
                <c:pt idx="4">
                  <c:v>97-120</c:v>
                </c:pt>
                <c:pt idx="5">
                  <c:v>121-144</c:v>
                </c:pt>
                <c:pt idx="6">
                  <c:v>145-168</c:v>
                </c:pt>
                <c:pt idx="7">
                  <c:v>169-192</c:v>
                </c:pt>
                <c:pt idx="8">
                  <c:v>193-216</c:v>
                </c:pt>
                <c:pt idx="9">
                  <c:v>217-240</c:v>
                </c:pt>
                <c:pt idx="10">
                  <c:v>240-</c:v>
                </c:pt>
                <c:pt idx="11">
                  <c:v>no fever</c:v>
                </c:pt>
              </c:strCache>
            </c:strRef>
          </c:cat>
          <c:val>
            <c:numRef>
              <c:f>Sheet1!$D$2:$D$13</c:f>
              <c:numCache>
                <c:formatCode>General</c:formatCode>
                <c:ptCount val="12"/>
                <c:pt idx="0">
                  <c:v>6</c:v>
                </c:pt>
                <c:pt idx="1">
                  <c:v>3</c:v>
                </c:pt>
                <c:pt idx="2">
                  <c:v>10</c:v>
                </c:pt>
                <c:pt idx="3">
                  <c:v>10</c:v>
                </c:pt>
                <c:pt idx="4">
                  <c:v>12</c:v>
                </c:pt>
                <c:pt idx="5">
                  <c:v>7</c:v>
                </c:pt>
                <c:pt idx="6">
                  <c:v>7</c:v>
                </c:pt>
                <c:pt idx="7">
                  <c:v>4</c:v>
                </c:pt>
                <c:pt idx="9">
                  <c:v>1</c:v>
                </c:pt>
                <c:pt idx="10">
                  <c:v>6</c:v>
                </c:pt>
                <c:pt idx="11">
                  <c:v>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E84-47A2-AB42-5E66CD168D1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391561824"/>
        <c:axId val="1712472880"/>
      </c:barChart>
      <c:catAx>
        <c:axId val="13915618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/>
                </a:solidFill>
                <a:latin typeface="Century" panose="02040604050505020304" pitchFamily="18" charset="0"/>
                <a:ea typeface="+mn-ea"/>
                <a:cs typeface="+mn-cs"/>
              </a:defRPr>
            </a:pPr>
            <a:endParaRPr lang="ja-JP"/>
          </a:p>
        </c:txPr>
        <c:crossAx val="1712472880"/>
        <c:crosses val="autoZero"/>
        <c:auto val="1"/>
        <c:lblAlgn val="ctr"/>
        <c:lblOffset val="100"/>
        <c:noMultiLvlLbl val="0"/>
      </c:catAx>
      <c:valAx>
        <c:axId val="17124728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/>
                </a:solidFill>
                <a:latin typeface="Century" panose="02040604050505020304" pitchFamily="18" charset="0"/>
                <a:ea typeface="+mn-ea"/>
                <a:cs typeface="+mn-cs"/>
              </a:defRPr>
            </a:pPr>
            <a:endParaRPr lang="ja-JP"/>
          </a:p>
        </c:txPr>
        <c:crossAx val="139156182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43184475129014677"/>
          <c:y val="4.0074052547852658E-2"/>
          <c:w val="0.55176930782202949"/>
          <c:h val="0.25462581854133143"/>
        </c:manualLayout>
      </c:layout>
      <c:overlay val="1"/>
      <c:spPr>
        <a:solidFill>
          <a:schemeClr val="bg1"/>
        </a:solidFill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Century" panose="02040604050505020304" pitchFamily="18" charset="0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FDB0027-5483-4264-8020-45052CBE92D3}" type="datetimeFigureOut">
              <a:rPr kumimoji="1" lang="ja-JP" altLang="en-US" smtClean="0"/>
              <a:t>2021/8/2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4B1F9D4-68F9-41DE-9140-A4971A078F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92968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Age groups and detection of M. pneumoniae DNA by real-time PCR.  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4B1F9D4-68F9-41DE-9140-A4971A078FCA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17395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C57A1-1921-41D8-A514-93A822FDE6A8}" type="datetimeFigureOut">
              <a:rPr kumimoji="1" lang="ja-JP" altLang="en-US" smtClean="0"/>
              <a:t>2021/8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64A71-61DC-4923-8CCE-6076A63A8C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27818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C57A1-1921-41D8-A514-93A822FDE6A8}" type="datetimeFigureOut">
              <a:rPr kumimoji="1" lang="ja-JP" altLang="en-US" smtClean="0"/>
              <a:t>2021/8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64A71-61DC-4923-8CCE-6076A63A8C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19522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C57A1-1921-41D8-A514-93A822FDE6A8}" type="datetimeFigureOut">
              <a:rPr kumimoji="1" lang="ja-JP" altLang="en-US" smtClean="0"/>
              <a:t>2021/8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64A71-61DC-4923-8CCE-6076A63A8C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5232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C57A1-1921-41D8-A514-93A822FDE6A8}" type="datetimeFigureOut">
              <a:rPr kumimoji="1" lang="ja-JP" altLang="en-US" smtClean="0"/>
              <a:t>2021/8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64A71-61DC-4923-8CCE-6076A63A8C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64500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C57A1-1921-41D8-A514-93A822FDE6A8}" type="datetimeFigureOut">
              <a:rPr kumimoji="1" lang="ja-JP" altLang="en-US" smtClean="0"/>
              <a:t>2021/8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64A71-61DC-4923-8CCE-6076A63A8C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13231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C57A1-1921-41D8-A514-93A822FDE6A8}" type="datetimeFigureOut">
              <a:rPr kumimoji="1" lang="ja-JP" altLang="en-US" smtClean="0"/>
              <a:t>2021/8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64A71-61DC-4923-8CCE-6076A63A8C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02290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C57A1-1921-41D8-A514-93A822FDE6A8}" type="datetimeFigureOut">
              <a:rPr kumimoji="1" lang="ja-JP" altLang="en-US" smtClean="0"/>
              <a:t>2021/8/2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64A71-61DC-4923-8CCE-6076A63A8C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60779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C57A1-1921-41D8-A514-93A822FDE6A8}" type="datetimeFigureOut">
              <a:rPr kumimoji="1" lang="ja-JP" altLang="en-US" smtClean="0"/>
              <a:t>2021/8/2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64A71-61DC-4923-8CCE-6076A63A8C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29313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C57A1-1921-41D8-A514-93A822FDE6A8}" type="datetimeFigureOut">
              <a:rPr kumimoji="1" lang="ja-JP" altLang="en-US" smtClean="0"/>
              <a:t>2021/8/2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64A71-61DC-4923-8CCE-6076A63A8C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51862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C57A1-1921-41D8-A514-93A822FDE6A8}" type="datetimeFigureOut">
              <a:rPr kumimoji="1" lang="ja-JP" altLang="en-US" smtClean="0"/>
              <a:t>2021/8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64A71-61DC-4923-8CCE-6076A63A8C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8025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C57A1-1921-41D8-A514-93A822FDE6A8}" type="datetimeFigureOut">
              <a:rPr kumimoji="1" lang="ja-JP" altLang="en-US" smtClean="0"/>
              <a:t>2021/8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64A71-61DC-4923-8CCE-6076A63A8C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08075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3C57A1-1921-41D8-A514-93A822FDE6A8}" type="datetimeFigureOut">
              <a:rPr kumimoji="1" lang="ja-JP" altLang="en-US" smtClean="0"/>
              <a:t>2021/8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B64A71-61DC-4923-8CCE-6076A63A8C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44314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コンテンツ プレースホルダー 7">
            <a:extLst>
              <a:ext uri="{FF2B5EF4-FFF2-40B4-BE49-F238E27FC236}">
                <a16:creationId xmlns:a16="http://schemas.microsoft.com/office/drawing/2014/main" id="{E30BD78A-E2D6-4630-885C-B69D68A1EC4D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58914158"/>
              </p:ext>
            </p:extLst>
          </p:nvPr>
        </p:nvGraphicFramePr>
        <p:xfrm>
          <a:off x="628650" y="1125415"/>
          <a:ext cx="7886700" cy="50515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2572FE68-FD97-4530-8C1B-9986DA02DDB3}"/>
              </a:ext>
            </a:extLst>
          </p:cNvPr>
          <p:cNvSpPr/>
          <p:nvPr/>
        </p:nvSpPr>
        <p:spPr>
          <a:xfrm>
            <a:off x="2259960" y="6234737"/>
            <a:ext cx="479971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400" dirty="0">
                <a:latin typeface="Century" panose="02040604050505020304" pitchFamily="18" charset="0"/>
              </a:rPr>
              <a:t>Period from onset of fever to pharyngeal swab</a:t>
            </a:r>
            <a:r>
              <a:rPr lang="ja-JP" altLang="en-US" sz="1400" dirty="0">
                <a:latin typeface="Century" panose="02040604050505020304" pitchFamily="18" charset="0"/>
              </a:rPr>
              <a:t> </a:t>
            </a:r>
            <a:r>
              <a:rPr lang="en-US" altLang="ja-JP" sz="1400" dirty="0">
                <a:latin typeface="Century" panose="02040604050505020304" pitchFamily="18" charset="0"/>
              </a:rPr>
              <a:t>sampling</a:t>
            </a:r>
            <a:endParaRPr lang="ja-JP" altLang="en-US" sz="1400" dirty="0">
              <a:latin typeface="Century" panose="02040604050505020304" pitchFamily="18" charset="0"/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0B34ECC6-D382-4B7E-A567-1A66982AE8D4}"/>
              </a:ext>
            </a:extLst>
          </p:cNvPr>
          <p:cNvSpPr/>
          <p:nvPr/>
        </p:nvSpPr>
        <p:spPr>
          <a:xfrm>
            <a:off x="8358026" y="5864794"/>
            <a:ext cx="69281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0" dirty="0">
                <a:latin typeface="Century" panose="02040604050505020304" pitchFamily="18" charset="0"/>
              </a:rPr>
              <a:t>(hours)</a:t>
            </a:r>
            <a:endParaRPr lang="ja-JP" altLang="en-US" sz="1200" dirty="0">
              <a:latin typeface="Century" panose="020406040505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F04C06D3-1668-47D1-BFB5-AB3D82961971}"/>
              </a:ext>
            </a:extLst>
          </p:cNvPr>
          <p:cNvSpPr txBox="1"/>
          <p:nvPr/>
        </p:nvSpPr>
        <p:spPr>
          <a:xfrm rot="16200000">
            <a:off x="-196940" y="3404364"/>
            <a:ext cx="11544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Century" panose="02040604050505020304" pitchFamily="18" charset="0"/>
              </a:rPr>
              <a:t>No. of cases</a:t>
            </a:r>
            <a:endParaRPr kumimoji="1" lang="ja-JP" altLang="en-US" sz="1400" dirty="0">
              <a:latin typeface="Century" panose="020406040505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809618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94</TotalTime>
  <Words>30</Words>
  <Application>Microsoft Office PowerPoint</Application>
  <PresentationFormat>画面に合わせる (4:3)</PresentationFormat>
  <Paragraphs>5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Century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石黒　信久</dc:creator>
  <cp:lastModifiedBy>石黒　信久</cp:lastModifiedBy>
  <cp:revision>32</cp:revision>
  <dcterms:created xsi:type="dcterms:W3CDTF">2021-01-23T10:40:31Z</dcterms:created>
  <dcterms:modified xsi:type="dcterms:W3CDTF">2021-08-24T07:41:19Z</dcterms:modified>
</cp:coreProperties>
</file>